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12192000" cy="11015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32"/>
  </p:normalViewPr>
  <p:slideViewPr>
    <p:cSldViewPr snapToGrid="0" snapToObjects="1">
      <p:cViewPr varScale="1">
        <p:scale>
          <a:sx n="47" d="100"/>
          <a:sy n="47" d="100"/>
        </p:scale>
        <p:origin x="159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802795"/>
            <a:ext cx="10363200" cy="3835083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785774"/>
            <a:ext cx="9144000" cy="265956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600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00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86482"/>
            <a:ext cx="2628900" cy="933526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86482"/>
            <a:ext cx="7734300" cy="933526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84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826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746269"/>
            <a:ext cx="10515600" cy="458220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371828"/>
            <a:ext cx="10515600" cy="240967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617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932410"/>
            <a:ext cx="5181600" cy="698933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932410"/>
            <a:ext cx="5181600" cy="698933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356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86484"/>
            <a:ext cx="10515600" cy="212918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700368"/>
            <a:ext cx="5157787" cy="132340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023777"/>
            <a:ext cx="5157787" cy="591837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700368"/>
            <a:ext cx="5183188" cy="132340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023777"/>
            <a:ext cx="5183188" cy="591837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898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057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965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4378"/>
            <a:ext cx="3932237" cy="257032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86054"/>
            <a:ext cx="6172200" cy="782826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304699"/>
            <a:ext cx="3932237" cy="612236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18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4378"/>
            <a:ext cx="3932237" cy="2570321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86054"/>
            <a:ext cx="6172200" cy="782826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304699"/>
            <a:ext cx="3932237" cy="612236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370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86484"/>
            <a:ext cx="10515600" cy="21291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932410"/>
            <a:ext cx="10515600" cy="69893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209890"/>
            <a:ext cx="2743200" cy="58648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86CC8-38FF-E140-8A2C-2698B9D00559}" type="datetimeFigureOut">
              <a:rPr lang="en-US" smtClean="0"/>
              <a:t>7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209890"/>
            <a:ext cx="4114800" cy="58648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209890"/>
            <a:ext cx="2743200" cy="58648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DC1A18-7903-5C47-97F0-5BEF6C465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12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00BA5916-0071-2541-BCDA-5599CE23FC7E}"/>
              </a:ext>
            </a:extLst>
          </p:cNvPr>
          <p:cNvGrpSpPr/>
          <p:nvPr/>
        </p:nvGrpSpPr>
        <p:grpSpPr>
          <a:xfrm>
            <a:off x="433486" y="487623"/>
            <a:ext cx="10023590" cy="5338551"/>
            <a:chOff x="468205" y="2064226"/>
            <a:chExt cx="10756228" cy="5373992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22A19F7A-8172-994C-82F2-69FFBFDFAEB8}"/>
                </a:ext>
              </a:extLst>
            </p:cNvPr>
            <p:cNvGrpSpPr/>
            <p:nvPr/>
          </p:nvGrpSpPr>
          <p:grpSpPr>
            <a:xfrm>
              <a:off x="1128334" y="2660750"/>
              <a:ext cx="5814551" cy="4777468"/>
              <a:chOff x="951952" y="3886078"/>
              <a:chExt cx="4270400" cy="3208314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xmlns="" id="{B69ECA88-5160-6341-B96D-FA116D8CA5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50"/>
              <a:stretch/>
            </p:blipFill>
            <p:spPr>
              <a:xfrm>
                <a:off x="951952" y="3886078"/>
                <a:ext cx="3980696" cy="2401087"/>
              </a:xfrm>
              <a:prstGeom prst="rect">
                <a:avLst/>
              </a:prstGeom>
            </p:spPr>
          </p:pic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xmlns="" id="{675598C2-C31D-7F46-BD8C-70609A7146FD}"/>
                  </a:ext>
                </a:extLst>
              </p:cNvPr>
              <p:cNvSpPr/>
              <p:nvPr/>
            </p:nvSpPr>
            <p:spPr>
              <a:xfrm>
                <a:off x="2360154" y="6759203"/>
                <a:ext cx="133350" cy="91440"/>
              </a:xfrm>
              <a:prstGeom prst="rect">
                <a:avLst/>
              </a:prstGeom>
              <a:solidFill>
                <a:srgbClr val="65B0F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xmlns="" id="{2C0BAAFE-E544-1147-885E-8E4A517F5803}"/>
                  </a:ext>
                </a:extLst>
              </p:cNvPr>
              <p:cNvSpPr/>
              <p:nvPr/>
            </p:nvSpPr>
            <p:spPr>
              <a:xfrm>
                <a:off x="2360154" y="6915726"/>
                <a:ext cx="133350" cy="91440"/>
              </a:xfrm>
              <a:prstGeom prst="rect">
                <a:avLst/>
              </a:prstGeom>
              <a:solidFill>
                <a:srgbClr val="FF999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xmlns="" id="{0C0F2B42-B789-4B47-9CA7-67448D3CBBD7}"/>
                  </a:ext>
                </a:extLst>
              </p:cNvPr>
              <p:cNvSpPr/>
              <p:nvPr/>
            </p:nvSpPr>
            <p:spPr>
              <a:xfrm>
                <a:off x="2360154" y="6602680"/>
                <a:ext cx="133350" cy="91440"/>
              </a:xfrm>
              <a:prstGeom prst="rect">
                <a:avLst/>
              </a:prstGeom>
              <a:solidFill>
                <a:srgbClr val="C8FBB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xmlns="" id="{1C8C4DF3-72EE-6145-8103-47152555AE11}"/>
                  </a:ext>
                </a:extLst>
              </p:cNvPr>
              <p:cNvSpPr txBox="1"/>
              <p:nvPr/>
            </p:nvSpPr>
            <p:spPr>
              <a:xfrm>
                <a:off x="2490390" y="6591313"/>
                <a:ext cx="609188" cy="1872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thway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xmlns="" id="{06CAF64A-8829-E94F-A2AF-0C8C00409963}"/>
                  </a:ext>
                </a:extLst>
              </p:cNvPr>
              <p:cNvSpPr txBox="1"/>
              <p:nvPr/>
            </p:nvSpPr>
            <p:spPr>
              <a:xfrm>
                <a:off x="2490390" y="6750615"/>
                <a:ext cx="1339403" cy="1872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own Regulated gene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xmlns="" id="{CA749711-A0FD-5E48-8C23-EE3BB591BD78}"/>
                  </a:ext>
                </a:extLst>
              </p:cNvPr>
              <p:cNvSpPr txBox="1"/>
              <p:nvPr/>
            </p:nvSpPr>
            <p:spPr>
              <a:xfrm>
                <a:off x="2490390" y="6907138"/>
                <a:ext cx="1185275" cy="1872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p Regulated gene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Oval 11">
                <a:extLst>
                  <a:ext uri="{FF2B5EF4-FFF2-40B4-BE49-F238E27FC236}">
                    <a16:creationId xmlns:a16="http://schemas.microsoft.com/office/drawing/2014/main" xmlns="" id="{65B4D9F7-F9A5-534E-B4B9-355F105630D7}"/>
                  </a:ext>
                </a:extLst>
              </p:cNvPr>
              <p:cNvSpPr/>
              <p:nvPr/>
            </p:nvSpPr>
            <p:spPr>
              <a:xfrm>
                <a:off x="4098693" y="6942883"/>
                <a:ext cx="95250" cy="9525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Oval 12">
                <a:extLst>
                  <a:ext uri="{FF2B5EF4-FFF2-40B4-BE49-F238E27FC236}">
                    <a16:creationId xmlns:a16="http://schemas.microsoft.com/office/drawing/2014/main" xmlns="" id="{6BFA19BB-2A29-8C41-B98E-4CDAB7918A22}"/>
                  </a:ext>
                </a:extLst>
              </p:cNvPr>
              <p:cNvSpPr/>
              <p:nvPr/>
            </p:nvSpPr>
            <p:spPr>
              <a:xfrm>
                <a:off x="4015448" y="6532856"/>
                <a:ext cx="242570" cy="24257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" name="Straight Arrow Connector 13">
                <a:extLst>
                  <a:ext uri="{FF2B5EF4-FFF2-40B4-BE49-F238E27FC236}">
                    <a16:creationId xmlns:a16="http://schemas.microsoft.com/office/drawing/2014/main" xmlns="" id="{D6229E95-9531-3A4D-9A1F-3754ED66BB08}"/>
                  </a:ext>
                </a:extLst>
              </p:cNvPr>
              <p:cNvCxnSpPr>
                <a:cxnSpLocks/>
                <a:endCxn id="13" idx="4"/>
              </p:cNvCxnSpPr>
              <p:nvPr/>
            </p:nvCxnSpPr>
            <p:spPr>
              <a:xfrm flipV="1">
                <a:off x="4136733" y="6775426"/>
                <a:ext cx="0" cy="16120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xmlns="" id="{F618C266-2A58-B14F-AF61-7686070637C3}"/>
                  </a:ext>
                </a:extLst>
              </p:cNvPr>
              <p:cNvSpPr txBox="1"/>
              <p:nvPr/>
            </p:nvSpPr>
            <p:spPr>
              <a:xfrm>
                <a:off x="4351651" y="6775427"/>
                <a:ext cx="870701" cy="1872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etweenness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D020E17D-A949-B94F-A51E-804C63B7D7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55" r="23000"/>
            <a:stretch/>
          </p:blipFill>
          <p:spPr>
            <a:xfrm>
              <a:off x="6335774" y="2064226"/>
              <a:ext cx="4888659" cy="4741438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68FA0528-A1E6-AB42-BCE6-C3373EAFFD3F}"/>
                </a:ext>
              </a:extLst>
            </p:cNvPr>
            <p:cNvSpPr txBox="1"/>
            <p:nvPr/>
          </p:nvSpPr>
          <p:spPr>
            <a:xfrm>
              <a:off x="468205" y="2386517"/>
              <a:ext cx="2300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67CA7712-FB9F-6B47-B5C9-E0FCFD5CD866}"/>
                </a:ext>
              </a:extLst>
            </p:cNvPr>
            <p:cNvSpPr txBox="1"/>
            <p:nvPr/>
          </p:nvSpPr>
          <p:spPr>
            <a:xfrm>
              <a:off x="2778917" y="2342007"/>
              <a:ext cx="178207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CLF vs HC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BB0B7556-68FA-E04A-AA53-EAB91329063E}"/>
                </a:ext>
              </a:extLst>
            </p:cNvPr>
            <p:cNvSpPr txBox="1"/>
            <p:nvPr/>
          </p:nvSpPr>
          <p:spPr>
            <a:xfrm>
              <a:off x="8989768" y="2119737"/>
              <a:ext cx="178207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CLF vs CLD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D9C0C549-BC72-024A-A82F-9BA044A95097}"/>
              </a:ext>
            </a:extLst>
          </p:cNvPr>
          <p:cNvSpPr txBox="1"/>
          <p:nvPr/>
        </p:nvSpPr>
        <p:spPr>
          <a:xfrm>
            <a:off x="352811" y="6383595"/>
            <a:ext cx="3757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DA951ABD-DE57-BD48-ADCD-CFC696B13978}"/>
              </a:ext>
            </a:extLst>
          </p:cNvPr>
          <p:cNvSpPr txBox="1"/>
          <p:nvPr/>
        </p:nvSpPr>
        <p:spPr>
          <a:xfrm>
            <a:off x="460008" y="-1286487"/>
            <a:ext cx="3757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D2EBAA35-6DBC-0C4F-8DAE-D95836B44C00}"/>
              </a:ext>
            </a:extLst>
          </p:cNvPr>
          <p:cNvSpPr txBox="1"/>
          <p:nvPr/>
        </p:nvSpPr>
        <p:spPr>
          <a:xfrm>
            <a:off x="6559422" y="-2007258"/>
            <a:ext cx="3757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xmlns="" id="{FA1FCC99-A1EF-3C4F-81D0-8C6DB7D7F7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3489" y="6383595"/>
            <a:ext cx="3194683" cy="319865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xmlns="" id="{F7A2043D-34B2-B843-8EC0-2968509EAFA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67157" y="6353609"/>
            <a:ext cx="3046117" cy="3228642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B9F83122-B0B7-C948-BB83-4C1785932473}"/>
              </a:ext>
            </a:extLst>
          </p:cNvPr>
          <p:cNvSpPr txBox="1"/>
          <p:nvPr/>
        </p:nvSpPr>
        <p:spPr>
          <a:xfrm>
            <a:off x="-32857" y="9880836"/>
            <a:ext cx="118685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hways Analysis by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eGO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richr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eGO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reveal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 significant pathways for ACLF vs HC  and 15 significant pathways for ACLF vs CLD . Inflammatory modules observed in SLE, RA, and IBD were upregulated in ACLF vs CLD suggesting commonalities in PMN inflammatory profiles from these diseases.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ric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showed 18 significantly altered pathways for ACLF vs HC and 22 significantly altered pathways for ACLF vs CLD.  The inflammatory modules seen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ric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were similar to those observed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e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17 cytokine response pathway was also seen as a common outcome of both analyses. The enrichment criteria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e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set for detailed network specificity at 5% genes for clustering and pathway significance of p-value &lt;= 0.05.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ric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significant pathways were selected at adjusted p-value &lt;= 0.05.</a:t>
            </a: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4427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</TotalTime>
  <Words>170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gyan Acharya</dc:creator>
  <cp:lastModifiedBy>lenovo-pc</cp:lastModifiedBy>
  <cp:revision>17</cp:revision>
  <dcterms:created xsi:type="dcterms:W3CDTF">2021-05-04T08:01:53Z</dcterms:created>
  <dcterms:modified xsi:type="dcterms:W3CDTF">2021-07-29T10:57:42Z</dcterms:modified>
</cp:coreProperties>
</file>